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  <p:sldId id="270" r:id="rId3"/>
    <p:sldId id="259" r:id="rId4"/>
    <p:sldId id="260" r:id="rId5"/>
    <p:sldId id="262" r:id="rId6"/>
    <p:sldId id="261" r:id="rId7"/>
    <p:sldId id="265" r:id="rId8"/>
    <p:sldId id="266" r:id="rId9"/>
    <p:sldId id="267" r:id="rId10"/>
    <p:sldId id="268" r:id="rId11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7" autoAdjust="0"/>
    <p:restoredTop sz="94660"/>
  </p:normalViewPr>
  <p:slideViewPr>
    <p:cSldViewPr snapToGrid="0">
      <p:cViewPr varScale="1">
        <p:scale>
          <a:sx n="89" d="100"/>
          <a:sy n="89" d="100"/>
        </p:scale>
        <p:origin x="-206" y="-6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5A95-4DCA-4958-8A73-9B06905AD843}" type="datetimeFigureOut">
              <a:rPr lang="fr-BE" smtClean="0"/>
              <a:t>3/10/2023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E1C58-4023-4DA9-9C4D-27CA564DDFF4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1584189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5A95-4DCA-4958-8A73-9B06905AD843}" type="datetimeFigureOut">
              <a:rPr lang="fr-BE" smtClean="0"/>
              <a:t>3/10/2023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E1C58-4023-4DA9-9C4D-27CA564DDFF4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53163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5A95-4DCA-4958-8A73-9B06905AD843}" type="datetimeFigureOut">
              <a:rPr lang="fr-BE" smtClean="0"/>
              <a:t>3/10/2023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E1C58-4023-4DA9-9C4D-27CA564DDFF4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1333734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5A95-4DCA-4958-8A73-9B06905AD843}" type="datetimeFigureOut">
              <a:rPr lang="fr-BE" smtClean="0"/>
              <a:t>3/10/2023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E1C58-4023-4DA9-9C4D-27CA564DDFF4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2543893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5A95-4DCA-4958-8A73-9B06905AD843}" type="datetimeFigureOut">
              <a:rPr lang="fr-BE" smtClean="0"/>
              <a:t>3/10/2023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E1C58-4023-4DA9-9C4D-27CA564DDFF4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5133402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5A95-4DCA-4958-8A73-9B06905AD843}" type="datetimeFigureOut">
              <a:rPr lang="fr-BE" smtClean="0"/>
              <a:t>3/10/2023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E1C58-4023-4DA9-9C4D-27CA564DDFF4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4374058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5A95-4DCA-4958-8A73-9B06905AD843}" type="datetimeFigureOut">
              <a:rPr lang="fr-BE" smtClean="0"/>
              <a:t>3/10/2023</a:t>
            </a:fld>
            <a:endParaRPr lang="fr-BE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E1C58-4023-4DA9-9C4D-27CA564DDFF4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621189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5A95-4DCA-4958-8A73-9B06905AD843}" type="datetimeFigureOut">
              <a:rPr lang="fr-BE" smtClean="0"/>
              <a:t>3/10/2023</a:t>
            </a:fld>
            <a:endParaRPr lang="fr-BE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E1C58-4023-4DA9-9C4D-27CA564DDFF4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8932542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5A95-4DCA-4958-8A73-9B06905AD843}" type="datetimeFigureOut">
              <a:rPr lang="fr-BE" smtClean="0"/>
              <a:t>3/10/2023</a:t>
            </a:fld>
            <a:endParaRPr lang="fr-BE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E1C58-4023-4DA9-9C4D-27CA564DDFF4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2554718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5A95-4DCA-4958-8A73-9B06905AD843}" type="datetimeFigureOut">
              <a:rPr lang="fr-BE" smtClean="0"/>
              <a:t>3/10/2023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E1C58-4023-4DA9-9C4D-27CA564DDFF4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969701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365A95-4DCA-4958-8A73-9B06905AD843}" type="datetimeFigureOut">
              <a:rPr lang="fr-BE" smtClean="0"/>
              <a:t>3/10/2023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1E1C58-4023-4DA9-9C4D-27CA564DDFF4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864577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365A95-4DCA-4958-8A73-9B06905AD843}" type="datetimeFigureOut">
              <a:rPr lang="fr-BE" smtClean="0"/>
              <a:t>3/10/2023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1E1C58-4023-4DA9-9C4D-27CA564DDFF4}" type="slidenum">
              <a:rPr lang="fr-BE" smtClean="0"/>
              <a:t>‹N°›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382530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1952" y="265176"/>
            <a:ext cx="8388096" cy="6327648"/>
          </a:xfrm>
          <a:prstGeom prst="rect">
            <a:avLst/>
          </a:prstGeom>
        </p:spPr>
      </p:pic>
      <p:sp>
        <p:nvSpPr>
          <p:cNvPr id="3" name="ZoneTexte 2"/>
          <p:cNvSpPr txBox="1"/>
          <p:nvPr/>
        </p:nvSpPr>
        <p:spPr>
          <a:xfrm>
            <a:off x="430306" y="363071"/>
            <a:ext cx="152092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 smtClean="0"/>
              <a:t>EA.hy926 </a:t>
            </a:r>
            <a:r>
              <a:rPr lang="fr-BE" dirty="0" err="1" smtClean="0"/>
              <a:t>cells</a:t>
            </a:r>
            <a:endParaRPr lang="fr-BE" dirty="0" smtClean="0"/>
          </a:p>
          <a:p>
            <a:r>
              <a:rPr lang="fr-BE" dirty="0" smtClean="0"/>
              <a:t>Ctrl </a:t>
            </a:r>
            <a:r>
              <a:rPr lang="fr-BE" dirty="0" smtClean="0"/>
              <a:t>1h</a:t>
            </a:r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139358879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1952" y="265176"/>
            <a:ext cx="8388096" cy="6327648"/>
          </a:xfrm>
          <a:prstGeom prst="rect">
            <a:avLst/>
          </a:prstGeom>
        </p:spPr>
      </p:pic>
      <p:sp>
        <p:nvSpPr>
          <p:cNvPr id="4" name="ZoneTexte 3"/>
          <p:cNvSpPr txBox="1"/>
          <p:nvPr/>
        </p:nvSpPr>
        <p:spPr>
          <a:xfrm>
            <a:off x="430306" y="363071"/>
            <a:ext cx="16791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 smtClean="0"/>
              <a:t>Gal1 + gal3  30h</a:t>
            </a:r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9697657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1952" y="265176"/>
            <a:ext cx="8388096" cy="6327648"/>
          </a:xfrm>
          <a:prstGeom prst="rect">
            <a:avLst/>
          </a:prstGeom>
        </p:spPr>
      </p:pic>
      <p:sp>
        <p:nvSpPr>
          <p:cNvPr id="3" name="ZoneTexte 2"/>
          <p:cNvSpPr txBox="1"/>
          <p:nvPr/>
        </p:nvSpPr>
        <p:spPr>
          <a:xfrm>
            <a:off x="430306" y="363071"/>
            <a:ext cx="1562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 smtClean="0"/>
              <a:t>Gal1 + gal3  1h</a:t>
            </a:r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28800174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1952" y="265176"/>
            <a:ext cx="8388096" cy="6327648"/>
          </a:xfrm>
          <a:prstGeom prst="rect">
            <a:avLst/>
          </a:prstGeom>
        </p:spPr>
      </p:pic>
      <p:sp>
        <p:nvSpPr>
          <p:cNvPr id="3" name="ZoneTexte 2"/>
          <p:cNvSpPr txBox="1"/>
          <p:nvPr/>
        </p:nvSpPr>
        <p:spPr>
          <a:xfrm>
            <a:off x="430306" y="363071"/>
            <a:ext cx="8098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 smtClean="0"/>
              <a:t>Ctrl 6h</a:t>
            </a:r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38734885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1952" y="265176"/>
            <a:ext cx="8388096" cy="6327648"/>
          </a:xfrm>
          <a:prstGeom prst="rect">
            <a:avLst/>
          </a:prstGeom>
        </p:spPr>
      </p:pic>
      <p:sp>
        <p:nvSpPr>
          <p:cNvPr id="3" name="ZoneTexte 2"/>
          <p:cNvSpPr txBox="1"/>
          <p:nvPr/>
        </p:nvSpPr>
        <p:spPr>
          <a:xfrm>
            <a:off x="430306" y="363071"/>
            <a:ext cx="8616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 smtClean="0"/>
              <a:t>gal1 6h</a:t>
            </a:r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228031519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1952" y="265176"/>
            <a:ext cx="8388096" cy="6327648"/>
          </a:xfrm>
          <a:prstGeom prst="rect">
            <a:avLst/>
          </a:prstGeom>
        </p:spPr>
      </p:pic>
      <p:sp>
        <p:nvSpPr>
          <p:cNvPr id="3" name="ZoneTexte 2"/>
          <p:cNvSpPr txBox="1"/>
          <p:nvPr/>
        </p:nvSpPr>
        <p:spPr>
          <a:xfrm>
            <a:off x="430306" y="363071"/>
            <a:ext cx="9145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 smtClean="0"/>
              <a:t>gal3  6h</a:t>
            </a:r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8620499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1952" y="265176"/>
            <a:ext cx="8388096" cy="6327648"/>
          </a:xfrm>
          <a:prstGeom prst="rect">
            <a:avLst/>
          </a:prstGeom>
        </p:spPr>
      </p:pic>
      <p:sp>
        <p:nvSpPr>
          <p:cNvPr id="3" name="ZoneTexte 2"/>
          <p:cNvSpPr txBox="1"/>
          <p:nvPr/>
        </p:nvSpPr>
        <p:spPr>
          <a:xfrm>
            <a:off x="430306" y="363071"/>
            <a:ext cx="1562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 smtClean="0"/>
              <a:t>Gal1 + gal3  6h</a:t>
            </a:r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317803071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1952" y="265176"/>
            <a:ext cx="8388096" cy="6327648"/>
          </a:xfrm>
          <a:prstGeom prst="rect">
            <a:avLst/>
          </a:prstGeom>
        </p:spPr>
      </p:pic>
      <p:sp>
        <p:nvSpPr>
          <p:cNvPr id="4" name="ZoneTexte 3"/>
          <p:cNvSpPr txBox="1"/>
          <p:nvPr/>
        </p:nvSpPr>
        <p:spPr>
          <a:xfrm>
            <a:off x="430306" y="363071"/>
            <a:ext cx="9268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 smtClean="0"/>
              <a:t>Ctrl 30h</a:t>
            </a:r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407616007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1952" y="265176"/>
            <a:ext cx="8388096" cy="6327648"/>
          </a:xfrm>
          <a:prstGeom prst="rect">
            <a:avLst/>
          </a:prstGeom>
        </p:spPr>
      </p:pic>
      <p:sp>
        <p:nvSpPr>
          <p:cNvPr id="3" name="ZoneTexte 2"/>
          <p:cNvSpPr txBox="1"/>
          <p:nvPr/>
        </p:nvSpPr>
        <p:spPr>
          <a:xfrm>
            <a:off x="430306" y="363071"/>
            <a:ext cx="978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 smtClean="0"/>
              <a:t>gal1 30h</a:t>
            </a:r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290809091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1952" y="265176"/>
            <a:ext cx="8388096" cy="6327648"/>
          </a:xfrm>
          <a:prstGeom prst="rect">
            <a:avLst/>
          </a:prstGeom>
        </p:spPr>
      </p:pic>
      <p:sp>
        <p:nvSpPr>
          <p:cNvPr id="3" name="ZoneTexte 2"/>
          <p:cNvSpPr txBox="1"/>
          <p:nvPr/>
        </p:nvSpPr>
        <p:spPr>
          <a:xfrm>
            <a:off x="430306" y="363071"/>
            <a:ext cx="10315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dirty="0" smtClean="0"/>
              <a:t>gal3  30h</a:t>
            </a:r>
            <a:endParaRPr lang="fr-BE" dirty="0"/>
          </a:p>
        </p:txBody>
      </p:sp>
    </p:spTree>
    <p:extLst>
      <p:ext uri="{BB962C8B-B14F-4D97-AF65-F5344CB8AC3E}">
        <p14:creationId xmlns:p14="http://schemas.microsoft.com/office/powerpoint/2010/main" val="236860905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28</Words>
  <Application>Microsoft Office PowerPoint</Application>
  <PresentationFormat>Personnalisé</PresentationFormat>
  <Paragraphs>11</Paragraphs>
  <Slides>1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0</vt:i4>
      </vt:variant>
    </vt:vector>
  </HeadingPairs>
  <TitlesOfParts>
    <vt:vector size="11" baseType="lpstr"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H.U.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D'Haene  Nicky</dc:creator>
  <cp:lastModifiedBy>nicky_dhaene</cp:lastModifiedBy>
  <cp:revision>4</cp:revision>
  <dcterms:created xsi:type="dcterms:W3CDTF">2023-10-01T12:58:00Z</dcterms:created>
  <dcterms:modified xsi:type="dcterms:W3CDTF">2023-10-03T20:34:00Z</dcterms:modified>
</cp:coreProperties>
</file>